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8FE69D-8F2F-4866-8A03-79E11F45C47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8EF8A5-C4F0-4DBC-8AB5-BF7D0EF981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0A93D8-93DF-48FB-A224-D556D7EB3F5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E33205-B0B7-45F0-AF66-9325E55F34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538BC-9654-4E11-B260-42A1692F1B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ACEB04-9F8C-4E2E-BD34-54DFF5B810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275C43-782E-4B78-B0C6-E816F9D76A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AE6123-0C15-40F0-A1D0-9EC673C40B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0D2E14-0960-4577-8217-37DCAABBE4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133AAF-9D47-47B1-B068-6503E86ABD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281DC2-200C-4976-BB4C-37745220CB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AFD187-F887-4F63-BDA2-9882A20533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A06A391-2937-41B9-BB1D-5A37F6277D3A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Operazione manuale 8"/>
          <p:cNvGrpSpPr/>
          <p:nvPr/>
        </p:nvGrpSpPr>
        <p:grpSpPr>
          <a:xfrm>
            <a:off x="957240" y="1279440"/>
            <a:ext cx="3584520" cy="2244960"/>
            <a:chOff x="957240" y="1279440"/>
            <a:chExt cx="3584520" cy="2244960"/>
          </a:xfrm>
        </p:grpSpPr>
        <p:pic>
          <p:nvPicPr>
            <p:cNvPr id="42" name="Operazione manuale 8" descr=""/>
            <p:cNvPicPr/>
            <p:nvPr/>
          </p:nvPicPr>
          <p:blipFill>
            <a:blip r:embed="rId1"/>
            <a:stretch/>
          </p:blipFill>
          <p:spPr>
            <a:xfrm>
              <a:off x="957240" y="1279440"/>
              <a:ext cx="3584520" cy="2244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1008000" y="1330200"/>
              <a:ext cx="3167280" cy="1825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3200" spc="-1" strike="noStrike">
                  <a:solidFill>
                    <a:srgbClr val="ffffff"/>
                  </a:solidFill>
                  <a:latin typeface="Calibri"/>
                </a:rPr>
                <a:t>28 SNPs</a:t>
              </a:r>
              <a:endParaRPr b="0" lang="en-US" sz="3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4" name="Operazione manuale 9"/>
          <p:cNvGrpSpPr/>
          <p:nvPr/>
        </p:nvGrpSpPr>
        <p:grpSpPr>
          <a:xfrm>
            <a:off x="1500120" y="3286080"/>
            <a:ext cx="2498760" cy="1895400"/>
            <a:chOff x="1500120" y="3286080"/>
            <a:chExt cx="2498760" cy="1895400"/>
          </a:xfrm>
        </p:grpSpPr>
        <p:pic>
          <p:nvPicPr>
            <p:cNvPr id="45" name="Operazione manuale 9" descr=""/>
            <p:cNvPicPr/>
            <p:nvPr/>
          </p:nvPicPr>
          <p:blipFill>
            <a:blip r:embed="rId2"/>
            <a:stretch/>
          </p:blipFill>
          <p:spPr>
            <a:xfrm>
              <a:off x="1500120" y="3286080"/>
              <a:ext cx="2498760" cy="1895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"/>
            <p:cNvSpPr/>
            <p:nvPr/>
          </p:nvSpPr>
          <p:spPr>
            <a:xfrm>
              <a:off x="1965240" y="3335400"/>
              <a:ext cx="1252800" cy="1482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800" spc="-1" strike="noStrike">
                  <a:solidFill>
                    <a:srgbClr val="000000"/>
                  </a:solidFill>
                  <a:latin typeface="Calibri"/>
                </a:rPr>
                <a:t>6 SNPs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7" name="Fusione 10"/>
          <p:cNvGrpSpPr/>
          <p:nvPr/>
        </p:nvGrpSpPr>
        <p:grpSpPr>
          <a:xfrm>
            <a:off x="1859040" y="4962600"/>
            <a:ext cx="1695240" cy="1639800"/>
            <a:chOff x="1859040" y="4962600"/>
            <a:chExt cx="1695240" cy="1639800"/>
          </a:xfrm>
        </p:grpSpPr>
        <p:pic>
          <p:nvPicPr>
            <p:cNvPr id="48" name="Fusione 10" descr=""/>
            <p:cNvPicPr/>
            <p:nvPr/>
          </p:nvPicPr>
          <p:blipFill>
            <a:blip r:embed="rId3"/>
            <a:stretch/>
          </p:blipFill>
          <p:spPr>
            <a:xfrm>
              <a:off x="1859040" y="4962600"/>
              <a:ext cx="1695240" cy="1639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"/>
            <p:cNvSpPr/>
            <p:nvPr/>
          </p:nvSpPr>
          <p:spPr>
            <a:xfrm>
              <a:off x="2228760" y="5011560"/>
              <a:ext cx="641520" cy="61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Calibri"/>
                </a:rPr>
                <a:t>4 SNPs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0" name="Parentesi graffa aperta 13"/>
          <p:cNvSpPr/>
          <p:nvPr/>
        </p:nvSpPr>
        <p:spPr>
          <a:xfrm>
            <a:off x="3924360" y="3341520"/>
            <a:ext cx="431640" cy="1295640"/>
          </a:xfrm>
          <a:custGeom>
            <a:avLst/>
            <a:gdLst>
              <a:gd name="textAreaLeft" fmla="*/ 275760 w 431640"/>
              <a:gd name="textAreaRight" fmla="*/ 432000 w 431640"/>
              <a:gd name="textAreaTop" fmla="*/ 11160 h 1295640"/>
              <a:gd name="textAreaBottom" fmla="*/ 1284480 h 12956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300"/>
                  <a:pt x="10800" y="600"/>
                </a:cubicBezTo>
                <a:lnTo>
                  <a:pt x="10800" y="10200"/>
                </a:lnTo>
                <a:cubicBezTo>
                  <a:pt x="10800" y="10500"/>
                  <a:pt x="5400" y="10800"/>
                  <a:pt x="0" y="10800"/>
                </a:cubicBezTo>
                <a:cubicBezTo>
                  <a:pt x="5400" y="10800"/>
                  <a:pt x="10800" y="11100"/>
                  <a:pt x="10800" y="11400"/>
                </a:cubicBezTo>
                <a:lnTo>
                  <a:pt x="10800" y="21000"/>
                </a:lnTo>
                <a:cubicBezTo>
                  <a:pt x="10800" y="213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arentesi graffa aperta 14"/>
          <p:cNvSpPr/>
          <p:nvPr/>
        </p:nvSpPr>
        <p:spPr>
          <a:xfrm>
            <a:off x="3924360" y="1587600"/>
            <a:ext cx="431640" cy="1296720"/>
          </a:xfrm>
          <a:custGeom>
            <a:avLst/>
            <a:gdLst>
              <a:gd name="textAreaLeft" fmla="*/ 275760 w 431640"/>
              <a:gd name="textAreaRight" fmla="*/ 432000 w 431640"/>
              <a:gd name="textAreaTop" fmla="*/ 11160 h 1296720"/>
              <a:gd name="textAreaBottom" fmla="*/ 1285560 h 12967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300"/>
                  <a:pt x="10800" y="599"/>
                </a:cubicBezTo>
                <a:lnTo>
                  <a:pt x="10800" y="10201"/>
                </a:lnTo>
                <a:cubicBezTo>
                  <a:pt x="10800" y="10501"/>
                  <a:pt x="5400" y="10800"/>
                  <a:pt x="0" y="10800"/>
                </a:cubicBezTo>
                <a:cubicBezTo>
                  <a:pt x="5400" y="10800"/>
                  <a:pt x="10800" y="11100"/>
                  <a:pt x="10800" y="11399"/>
                </a:cubicBezTo>
                <a:lnTo>
                  <a:pt x="10800" y="21001"/>
                </a:lnTo>
                <a:cubicBezTo>
                  <a:pt x="10800" y="21301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arentesi graffa aperta 15"/>
          <p:cNvSpPr/>
          <p:nvPr/>
        </p:nvSpPr>
        <p:spPr>
          <a:xfrm>
            <a:off x="3924360" y="4940280"/>
            <a:ext cx="431640" cy="1297080"/>
          </a:xfrm>
          <a:custGeom>
            <a:avLst/>
            <a:gdLst>
              <a:gd name="textAreaLeft" fmla="*/ 275760 w 431640"/>
              <a:gd name="textAreaRight" fmla="*/ 432000 w 431640"/>
              <a:gd name="textAreaTop" fmla="*/ 11160 h 1297080"/>
              <a:gd name="textAreaBottom" fmla="*/ 1285920 h 129708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300"/>
                  <a:pt x="10800" y="599"/>
                </a:cubicBezTo>
                <a:lnTo>
                  <a:pt x="10800" y="10201"/>
                </a:lnTo>
                <a:cubicBezTo>
                  <a:pt x="10800" y="10501"/>
                  <a:pt x="5400" y="10800"/>
                  <a:pt x="0" y="10800"/>
                </a:cubicBezTo>
                <a:cubicBezTo>
                  <a:pt x="5400" y="10800"/>
                  <a:pt x="10800" y="11100"/>
                  <a:pt x="10800" y="11399"/>
                </a:cubicBezTo>
                <a:lnTo>
                  <a:pt x="10800" y="21001"/>
                </a:lnTo>
                <a:cubicBezTo>
                  <a:pt x="10800" y="21301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CasellaDiTesto 17"/>
          <p:cNvSpPr/>
          <p:nvPr/>
        </p:nvSpPr>
        <p:spPr>
          <a:xfrm>
            <a:off x="250920" y="547560"/>
            <a:ext cx="46814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2000" spc="-1" strike="noStrike">
                <a:solidFill>
                  <a:srgbClr val="000000"/>
                </a:solidFill>
                <a:latin typeface="Calibri"/>
              </a:rPr>
              <a:t>Number of SNPs genotyped in the 3 stage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CasellaDiTesto 18"/>
          <p:cNvSpPr/>
          <p:nvPr/>
        </p:nvSpPr>
        <p:spPr>
          <a:xfrm>
            <a:off x="5003640" y="547560"/>
            <a:ext cx="36007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2000" spc="-1" strike="noStrike">
                <a:solidFill>
                  <a:srgbClr val="000000"/>
                </a:solidFill>
                <a:latin typeface="Calibri"/>
              </a:rPr>
              <a:t>Number of subjects genotyped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CasellaDiTesto 19"/>
          <p:cNvSpPr/>
          <p:nvPr/>
        </p:nvSpPr>
        <p:spPr>
          <a:xfrm>
            <a:off x="34920" y="1555920"/>
            <a:ext cx="1873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2400" spc="-1" strike="noStrike">
                <a:solidFill>
                  <a:srgbClr val="000000"/>
                </a:solidFill>
                <a:latin typeface="Calibri"/>
              </a:rPr>
              <a:t>Phase I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CasellaDiTesto 20"/>
          <p:cNvSpPr/>
          <p:nvPr/>
        </p:nvSpPr>
        <p:spPr>
          <a:xfrm>
            <a:off x="34920" y="3284640"/>
            <a:ext cx="1801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2400" spc="-1" strike="noStrike">
                <a:solidFill>
                  <a:srgbClr val="000000"/>
                </a:solidFill>
                <a:latin typeface="Calibri"/>
              </a:rPr>
              <a:t>Phase I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CasellaDiTesto 21"/>
          <p:cNvSpPr/>
          <p:nvPr/>
        </p:nvSpPr>
        <p:spPr>
          <a:xfrm>
            <a:off x="34920" y="5084640"/>
            <a:ext cx="1873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2400" spc="-1" strike="noStrike">
                <a:solidFill>
                  <a:srgbClr val="000000"/>
                </a:solidFill>
                <a:latin typeface="Calibri"/>
              </a:rPr>
              <a:t>Phase II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CasellaDiTesto 22"/>
          <p:cNvSpPr/>
          <p:nvPr/>
        </p:nvSpPr>
        <p:spPr>
          <a:xfrm>
            <a:off x="4211640" y="1987560"/>
            <a:ext cx="309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Czech (</a:t>
            </a:r>
            <a:r>
              <a:rPr b="0" lang="en-GB" sz="1800" spc="-1" strike="noStrike">
                <a:solidFill>
                  <a:srgbClr val="000000"/>
                </a:solidFill>
                <a:latin typeface="Calibri"/>
              </a:rPr>
              <a:t>699 cases 622 controls</a:t>
            </a:r>
            <a:r>
              <a:rPr b="0" lang="it-IT" sz="1800" spc="-1" strike="noStrike">
                <a:solidFill>
                  <a:srgbClr val="000000"/>
                </a:solidFill>
                <a:latin typeface="Calibri"/>
              </a:rPr>
              <a:t>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CasellaDiTesto 25"/>
          <p:cNvSpPr/>
          <p:nvPr/>
        </p:nvSpPr>
        <p:spPr>
          <a:xfrm>
            <a:off x="7451640" y="1987560"/>
            <a:ext cx="1656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2000" spc="-1" strike="noStrike">
                <a:solidFill>
                  <a:srgbClr val="000000"/>
                </a:solidFill>
                <a:latin typeface="Calibri"/>
              </a:rPr>
              <a:t>N total=132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0" name="Gruppo 37"/>
          <p:cNvGrpSpPr/>
          <p:nvPr/>
        </p:nvGrpSpPr>
        <p:grpSpPr>
          <a:xfrm>
            <a:off x="4211640" y="3567240"/>
            <a:ext cx="3529080" cy="795600"/>
            <a:chOff x="4211640" y="3567240"/>
            <a:chExt cx="3529080" cy="795600"/>
          </a:xfrm>
        </p:grpSpPr>
        <p:sp>
          <p:nvSpPr>
            <p:cNvPr id="61" name="CasellaDiTesto 27"/>
            <p:cNvSpPr/>
            <p:nvPr/>
          </p:nvSpPr>
          <p:spPr>
            <a:xfrm>
              <a:off x="4211640" y="3567240"/>
              <a:ext cx="32990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800" spc="-1" strike="noStrike">
                  <a:solidFill>
                    <a:srgbClr val="000000"/>
                  </a:solidFill>
                  <a:latin typeface="Calibri"/>
                </a:rPr>
                <a:t>Czech (</a:t>
              </a:r>
              <a:r>
                <a:rPr b="0" lang="en-GB" sz="1800" spc="-1" strike="noStrike">
                  <a:solidFill>
                    <a:srgbClr val="000000"/>
                  </a:solidFill>
                  <a:latin typeface="Calibri"/>
                </a:rPr>
                <a:t>699 cases/622 controls</a:t>
              </a:r>
              <a:r>
                <a:rPr b="0" lang="it-IT" sz="1800" spc="-1" strike="noStrike">
                  <a:solidFill>
                    <a:srgbClr val="000000"/>
                  </a:solidFill>
                  <a:latin typeface="Calibri"/>
                </a:rPr>
                <a:t>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CasellaDiTesto 28"/>
            <p:cNvSpPr/>
            <p:nvPr/>
          </p:nvSpPr>
          <p:spPr>
            <a:xfrm>
              <a:off x="4211640" y="3994560"/>
              <a:ext cx="3529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800" spc="-1" strike="noStrike">
                  <a:solidFill>
                    <a:srgbClr val="000000"/>
                  </a:solidFill>
                  <a:latin typeface="Calibri"/>
                </a:rPr>
                <a:t>DACHS (</a:t>
              </a:r>
              <a:r>
                <a:rPr b="0" lang="en-GB" sz="1800" spc="-1" strike="noStrike">
                  <a:solidFill>
                    <a:srgbClr val="000000"/>
                  </a:solidFill>
                  <a:latin typeface="Calibri"/>
                </a:rPr>
                <a:t>1809 cases/1853 controls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3" name="Gruppo 33"/>
          <p:cNvGrpSpPr/>
          <p:nvPr/>
        </p:nvGrpSpPr>
        <p:grpSpPr>
          <a:xfrm>
            <a:off x="4211640" y="5011560"/>
            <a:ext cx="3456000" cy="1224360"/>
            <a:chOff x="4211640" y="5011560"/>
            <a:chExt cx="3456000" cy="1224360"/>
          </a:xfrm>
        </p:grpSpPr>
        <p:sp>
          <p:nvSpPr>
            <p:cNvPr id="64" name="CasellaDiTesto 34"/>
            <p:cNvSpPr/>
            <p:nvPr/>
          </p:nvSpPr>
          <p:spPr>
            <a:xfrm>
              <a:off x="4211640" y="5011560"/>
              <a:ext cx="3230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800" spc="-1" strike="noStrike">
                  <a:solidFill>
                    <a:srgbClr val="000000"/>
                  </a:solidFill>
                  <a:latin typeface="Calibri"/>
                </a:rPr>
                <a:t>Czech (</a:t>
              </a:r>
              <a:r>
                <a:rPr b="0" lang="en-GB" sz="1800" spc="-1" strike="noStrike">
                  <a:solidFill>
                    <a:srgbClr val="000000"/>
                  </a:solidFill>
                  <a:latin typeface="Calibri"/>
                </a:rPr>
                <a:t>699 cases/622 controls</a:t>
              </a:r>
              <a:r>
                <a:rPr b="0" lang="it-IT" sz="1800" spc="-1" strike="noStrike">
                  <a:solidFill>
                    <a:srgbClr val="000000"/>
                  </a:solidFill>
                  <a:latin typeface="Calibri"/>
                </a:rPr>
                <a:t>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CasellaDiTesto 35"/>
            <p:cNvSpPr/>
            <p:nvPr/>
          </p:nvSpPr>
          <p:spPr>
            <a:xfrm>
              <a:off x="4211640" y="5439600"/>
              <a:ext cx="3456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800" spc="-1" strike="noStrike">
                  <a:solidFill>
                    <a:srgbClr val="000000"/>
                  </a:solidFill>
                  <a:latin typeface="Calibri"/>
                </a:rPr>
                <a:t>DACHS (</a:t>
              </a:r>
              <a:r>
                <a:rPr b="0" lang="en-GB" sz="1800" spc="-1" strike="noStrike">
                  <a:solidFill>
                    <a:srgbClr val="000000"/>
                  </a:solidFill>
                  <a:latin typeface="Calibri"/>
                </a:rPr>
                <a:t>1809 cases/1853 controls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CasellaDiTesto 36"/>
            <p:cNvSpPr/>
            <p:nvPr/>
          </p:nvSpPr>
          <p:spPr>
            <a:xfrm>
              <a:off x="4211640" y="5867640"/>
              <a:ext cx="3456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800" spc="-1" strike="noStrike">
                  <a:solidFill>
                    <a:srgbClr val="000000"/>
                  </a:solidFill>
                  <a:latin typeface="Calibri"/>
                </a:rPr>
                <a:t>Kiel (</a:t>
              </a:r>
              <a:r>
                <a:rPr b="0" lang="en-GB" sz="1800" spc="-1" strike="noStrike">
                  <a:solidFill>
                    <a:srgbClr val="000000"/>
                  </a:solidFill>
                  <a:latin typeface="Calibri"/>
                </a:rPr>
                <a:t>2169 cases/1634controls)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7" name="CasellaDiTesto 38"/>
          <p:cNvSpPr/>
          <p:nvPr/>
        </p:nvSpPr>
        <p:spPr>
          <a:xfrm>
            <a:off x="7451640" y="3706920"/>
            <a:ext cx="1656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2000" spc="-1" strike="noStrike">
                <a:solidFill>
                  <a:srgbClr val="000000"/>
                </a:solidFill>
                <a:latin typeface="Calibri"/>
              </a:rPr>
              <a:t>N total=498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CasellaDiTesto 39"/>
          <p:cNvSpPr/>
          <p:nvPr/>
        </p:nvSpPr>
        <p:spPr>
          <a:xfrm>
            <a:off x="7451640" y="5435640"/>
            <a:ext cx="1656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2000" spc="-1" strike="noStrike">
                <a:solidFill>
                  <a:srgbClr val="000000"/>
                </a:solidFill>
                <a:latin typeface="Calibri"/>
              </a:rPr>
              <a:t>N total=878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3T14:47:13Z</dcterms:created>
  <dc:creator>COSMERI</dc:creator>
  <dc:description/>
  <dc:language>en-US</dc:language>
  <cp:lastModifiedBy>COSMERI</cp:lastModifiedBy>
  <dcterms:modified xsi:type="dcterms:W3CDTF">2011-05-20T13:05:21Z</dcterms:modified>
  <cp:revision>20</cp:revision>
  <dc:subject/>
  <dc:title>Diapositiva 1</dc:title>
</cp:coreProperties>
</file>